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4"/>
  </p:notesMasterIdLst>
  <p:sldIdLst>
    <p:sldId id="272" r:id="rId2"/>
    <p:sldId id="273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00"/>
    <a:srgbClr val="DAD500"/>
    <a:srgbClr val="F4EE00"/>
    <a:srgbClr val="FFCC00"/>
    <a:srgbClr val="FF5050"/>
    <a:srgbClr val="0000CC"/>
    <a:srgbClr val="FF6600"/>
    <a:srgbClr val="99CC00"/>
    <a:srgbClr val="99FF33"/>
    <a:srgbClr val="CCFF6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810" autoAdjust="0"/>
    <p:restoredTop sz="94671"/>
  </p:normalViewPr>
  <p:slideViewPr>
    <p:cSldViewPr snapToGrid="0">
      <p:cViewPr varScale="1">
        <p:scale>
          <a:sx n="67" d="100"/>
          <a:sy n="67" d="100"/>
        </p:scale>
        <p:origin x="1530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DC48623-5795-4CED-9C3C-EEB9BA6F5269}" type="datetimeFigureOut">
              <a:rPr lang="ko-KR" altLang="en-US" smtClean="0"/>
              <a:t>2025-11-28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ED08EF5-7F8E-4A04-99A5-9022DC8C42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4444928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ED08EF5-7F8E-4A04-99A5-9022DC8C4279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107213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CC6810-9EDB-45A9-8B92-0BB1EA11B631}" type="datetimeFigureOut">
              <a:rPr lang="ko-KR" altLang="en-US" smtClean="0"/>
              <a:t>2025-11-2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A3C2E7-9C1B-48CF-95FF-5447855CB78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416595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CC6810-9EDB-45A9-8B92-0BB1EA11B631}" type="datetimeFigureOut">
              <a:rPr lang="ko-KR" altLang="en-US" smtClean="0"/>
              <a:t>2025-11-2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A3C2E7-9C1B-48CF-95FF-5447855CB78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721006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CC6810-9EDB-45A9-8B92-0BB1EA11B631}" type="datetimeFigureOut">
              <a:rPr lang="ko-KR" altLang="en-US" smtClean="0"/>
              <a:t>2025-11-2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A3C2E7-9C1B-48CF-95FF-5447855CB78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60000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CC6810-9EDB-45A9-8B92-0BB1EA11B631}" type="datetimeFigureOut">
              <a:rPr lang="ko-KR" altLang="en-US" smtClean="0"/>
              <a:t>2025-11-2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A3C2E7-9C1B-48CF-95FF-5447855CB78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241065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CC6810-9EDB-45A9-8B92-0BB1EA11B631}" type="datetimeFigureOut">
              <a:rPr lang="ko-KR" altLang="en-US" smtClean="0"/>
              <a:t>2025-11-2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A3C2E7-9C1B-48CF-95FF-5447855CB78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973530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CC6810-9EDB-45A9-8B92-0BB1EA11B631}" type="datetimeFigureOut">
              <a:rPr lang="ko-KR" altLang="en-US" smtClean="0"/>
              <a:t>2025-11-28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A3C2E7-9C1B-48CF-95FF-5447855CB78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089029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CC6810-9EDB-45A9-8B92-0BB1EA11B631}" type="datetimeFigureOut">
              <a:rPr lang="ko-KR" altLang="en-US" smtClean="0"/>
              <a:t>2025-11-28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A3C2E7-9C1B-48CF-95FF-5447855CB78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352556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CC6810-9EDB-45A9-8B92-0BB1EA11B631}" type="datetimeFigureOut">
              <a:rPr lang="ko-KR" altLang="en-US" smtClean="0"/>
              <a:t>2025-11-28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A3C2E7-9C1B-48CF-95FF-5447855CB78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291339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CC6810-9EDB-45A9-8B92-0BB1EA11B631}" type="datetimeFigureOut">
              <a:rPr lang="ko-KR" altLang="en-US" smtClean="0"/>
              <a:t>2025-11-28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A3C2E7-9C1B-48CF-95FF-5447855CB78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792466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CC6810-9EDB-45A9-8B92-0BB1EA11B631}" type="datetimeFigureOut">
              <a:rPr lang="ko-KR" altLang="en-US" smtClean="0"/>
              <a:t>2025-11-28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A3C2E7-9C1B-48CF-95FF-5447855CB78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559281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CC6810-9EDB-45A9-8B92-0BB1EA11B631}" type="datetimeFigureOut">
              <a:rPr lang="ko-KR" altLang="en-US" smtClean="0"/>
              <a:t>2025-11-28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A3C2E7-9C1B-48CF-95FF-5447855CB78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04881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1CC6810-9EDB-45A9-8B92-0BB1EA11B631}" type="datetimeFigureOut">
              <a:rPr lang="ko-KR" altLang="en-US" smtClean="0"/>
              <a:t>2025-11-2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DA3C2E7-9C1B-48CF-95FF-5447855CB78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207137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그림 8">
            <a:extLst>
              <a:ext uri="{FF2B5EF4-FFF2-40B4-BE49-F238E27FC236}">
                <a16:creationId xmlns:a16="http://schemas.microsoft.com/office/drawing/2014/main" id="{76AF252C-FE0A-6E4E-8FDF-7752D5D4984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2032259">
            <a:off x="1742083" y="5503227"/>
            <a:ext cx="503862" cy="390493"/>
          </a:xfrm>
          <a:prstGeom prst="rect">
            <a:avLst/>
          </a:prstGeom>
        </p:spPr>
      </p:pic>
      <p:pic>
        <p:nvPicPr>
          <p:cNvPr id="8" name="그림 7">
            <a:extLst>
              <a:ext uri="{FF2B5EF4-FFF2-40B4-BE49-F238E27FC236}">
                <a16:creationId xmlns:a16="http://schemas.microsoft.com/office/drawing/2014/main" id="{2EDB0E2B-2F36-6B98-D6F2-CB6EFB5D9A7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 rot="5241572">
            <a:off x="1910800" y="5270623"/>
            <a:ext cx="213246" cy="359591"/>
          </a:xfrm>
          <a:prstGeom prst="rect">
            <a:avLst/>
          </a:prstGeom>
        </p:spPr>
      </p:pic>
      <p:pic>
        <p:nvPicPr>
          <p:cNvPr id="11" name="그림 10">
            <a:extLst>
              <a:ext uri="{FF2B5EF4-FFF2-40B4-BE49-F238E27FC236}">
                <a16:creationId xmlns:a16="http://schemas.microsoft.com/office/drawing/2014/main" id="{BD09455B-7129-CCE9-C2C5-C0F47902B92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 rot="15499729">
            <a:off x="1867541" y="3709152"/>
            <a:ext cx="299764" cy="446708"/>
          </a:xfrm>
          <a:prstGeom prst="rect">
            <a:avLst/>
          </a:prstGeom>
        </p:spPr>
      </p:pic>
      <p:pic>
        <p:nvPicPr>
          <p:cNvPr id="6" name="그림 5">
            <a:extLst>
              <a:ext uri="{FF2B5EF4-FFF2-40B4-BE49-F238E27FC236}">
                <a16:creationId xmlns:a16="http://schemas.microsoft.com/office/drawing/2014/main" id="{E97633F3-3BB3-0BA2-7D7F-061BF690EC27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 rot="20653490">
            <a:off x="1627771" y="2405404"/>
            <a:ext cx="610604" cy="457953"/>
          </a:xfrm>
          <a:prstGeom prst="rect">
            <a:avLst/>
          </a:prstGeom>
        </p:spPr>
      </p:pic>
      <p:pic>
        <p:nvPicPr>
          <p:cNvPr id="28" name="그림 27">
            <a:extLst>
              <a:ext uri="{FF2B5EF4-FFF2-40B4-BE49-F238E27FC236}">
                <a16:creationId xmlns:a16="http://schemas.microsoft.com/office/drawing/2014/main" id="{8E0126EF-D636-8A43-41E6-629124E664F1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 rot="17941876">
            <a:off x="1716319" y="2786457"/>
            <a:ext cx="523085" cy="676651"/>
          </a:xfrm>
          <a:prstGeom prst="rect">
            <a:avLst/>
          </a:prstGeom>
        </p:spPr>
      </p:pic>
      <p:pic>
        <p:nvPicPr>
          <p:cNvPr id="5" name="그림 4">
            <a:extLst>
              <a:ext uri="{FF2B5EF4-FFF2-40B4-BE49-F238E27FC236}">
                <a16:creationId xmlns:a16="http://schemas.microsoft.com/office/drawing/2014/main" id="{5D297EF3-CC5C-B63C-914D-93DB6357199D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 rot="19588756">
            <a:off x="1766282" y="4643113"/>
            <a:ext cx="558355" cy="477768"/>
          </a:xfrm>
          <a:prstGeom prst="rect">
            <a:avLst/>
          </a:prstGeom>
        </p:spPr>
      </p:pic>
      <p:pic>
        <p:nvPicPr>
          <p:cNvPr id="7" name="그림 6">
            <a:extLst>
              <a:ext uri="{FF2B5EF4-FFF2-40B4-BE49-F238E27FC236}">
                <a16:creationId xmlns:a16="http://schemas.microsoft.com/office/drawing/2014/main" id="{F45A4F75-EB11-AC57-EEB1-29D52012AB94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 rot="2874192">
            <a:off x="1762096" y="3342192"/>
            <a:ext cx="485139" cy="390807"/>
          </a:xfrm>
          <a:prstGeom prst="rect">
            <a:avLst/>
          </a:prstGeom>
        </p:spPr>
      </p:pic>
      <p:pic>
        <p:nvPicPr>
          <p:cNvPr id="10" name="그림 9">
            <a:extLst>
              <a:ext uri="{FF2B5EF4-FFF2-40B4-BE49-F238E27FC236}">
                <a16:creationId xmlns:a16="http://schemas.microsoft.com/office/drawing/2014/main" id="{5CD95BC9-B6BF-3A17-A8E9-1A6BCDFE33DB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 rot="3952523">
            <a:off x="1895083" y="6010485"/>
            <a:ext cx="219163" cy="370310"/>
          </a:xfrm>
          <a:prstGeom prst="rect">
            <a:avLst/>
          </a:prstGeom>
        </p:spPr>
      </p:pic>
      <p:pic>
        <p:nvPicPr>
          <p:cNvPr id="30" name="그림 29">
            <a:extLst>
              <a:ext uri="{FF2B5EF4-FFF2-40B4-BE49-F238E27FC236}">
                <a16:creationId xmlns:a16="http://schemas.microsoft.com/office/drawing/2014/main" id="{53DEE1F2-8EE2-6AAD-6396-4B851996EE43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 rot="20216350">
            <a:off x="1676718" y="4118957"/>
            <a:ext cx="665233" cy="409831"/>
          </a:xfrm>
          <a:prstGeom prst="rect">
            <a:avLst/>
          </a:prstGeom>
        </p:spPr>
      </p:pic>
      <p:graphicFrame>
        <p:nvGraphicFramePr>
          <p:cNvPr id="19" name="표 18">
            <a:extLst>
              <a:ext uri="{FF2B5EF4-FFF2-40B4-BE49-F238E27FC236}">
                <a16:creationId xmlns:a16="http://schemas.microsoft.com/office/drawing/2014/main" id="{181F62BC-8962-51A1-764F-603B9431453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54779795"/>
              </p:ext>
            </p:extLst>
          </p:nvPr>
        </p:nvGraphicFramePr>
        <p:xfrm>
          <a:off x="1419225" y="1987474"/>
          <a:ext cx="4162425" cy="4347845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057275">
                  <a:extLst>
                    <a:ext uri="{9D8B030D-6E8A-4147-A177-3AD203B41FA5}">
                      <a16:colId xmlns:a16="http://schemas.microsoft.com/office/drawing/2014/main" val="3375470729"/>
                    </a:ext>
                  </a:extLst>
                </a:gridCol>
                <a:gridCol w="514350">
                  <a:extLst>
                    <a:ext uri="{9D8B030D-6E8A-4147-A177-3AD203B41FA5}">
                      <a16:colId xmlns:a16="http://schemas.microsoft.com/office/drawing/2014/main" val="915784751"/>
                    </a:ext>
                  </a:extLst>
                </a:gridCol>
                <a:gridCol w="1609725">
                  <a:extLst>
                    <a:ext uri="{9D8B030D-6E8A-4147-A177-3AD203B41FA5}">
                      <a16:colId xmlns:a16="http://schemas.microsoft.com/office/drawing/2014/main" val="2525134807"/>
                    </a:ext>
                  </a:extLst>
                </a:gridCol>
                <a:gridCol w="447675">
                  <a:extLst>
                    <a:ext uri="{9D8B030D-6E8A-4147-A177-3AD203B41FA5}">
                      <a16:colId xmlns:a16="http://schemas.microsoft.com/office/drawing/2014/main" val="3139891026"/>
                    </a:ext>
                  </a:extLst>
                </a:gridCol>
                <a:gridCol w="533400">
                  <a:extLst>
                    <a:ext uri="{9D8B030D-6E8A-4147-A177-3AD203B41FA5}">
                      <a16:colId xmlns:a16="http://schemas.microsoft.com/office/drawing/2014/main" val="344190717"/>
                    </a:ext>
                  </a:extLst>
                </a:gridCol>
              </a:tblGrid>
              <a:tr h="149523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chemeClr val="tx1"/>
                          </a:solidFill>
                        </a:rPr>
                        <a:t>Network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 marL="36000" marR="36000" marT="36000" marB="3600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chemeClr val="tx1"/>
                          </a:solidFill>
                        </a:rPr>
                        <a:t># terms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 marL="36000" marR="36000" marT="36000" marB="3600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chemeClr val="tx1"/>
                          </a:solidFill>
                        </a:rPr>
                        <a:t>Representative &amp; </a:t>
                      </a:r>
                    </a:p>
                    <a:p>
                      <a:pPr algn="ctr" latinLnBrk="1"/>
                      <a:r>
                        <a:rPr lang="en-US" altLang="ko-KR" sz="1000" dirty="0">
                          <a:solidFill>
                            <a:schemeClr val="tx1"/>
                          </a:solidFill>
                        </a:rPr>
                        <a:t>dominant  terms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 marL="36000" marR="36000" marT="36000" marB="3600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i="1" dirty="0">
                          <a:solidFill>
                            <a:schemeClr val="tx1"/>
                          </a:solidFill>
                        </a:rPr>
                        <a:t>-log P</a:t>
                      </a:r>
                      <a:endParaRPr lang="ko-KR" altLang="en-US" sz="1000" i="1" dirty="0">
                        <a:solidFill>
                          <a:schemeClr val="tx1"/>
                        </a:solidFill>
                      </a:endParaRPr>
                    </a:p>
                  </a:txBody>
                  <a:tcPr marL="36000" marR="36000" marT="36000" marB="3600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chemeClr val="tx1"/>
                          </a:solidFill>
                        </a:rPr>
                        <a:t># genes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 marL="36000" marR="36000" marT="36000" marB="3600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00251697"/>
                  </a:ext>
                </a:extLst>
              </a:tr>
              <a:tr h="150159">
                <a:tc rowSpan="2">
                  <a:txBody>
                    <a:bodyPr/>
                    <a:lstStyle/>
                    <a:p>
                      <a:pPr algn="ctr" latinLnBrk="1"/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 marL="36000" marR="36000" marT="36000" marB="3600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chemeClr val="tx1"/>
                          </a:solidFill>
                        </a:rPr>
                        <a:t>14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 marL="36000" marR="36000" marT="36000" marB="3600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chemeClr val="tx1"/>
                          </a:solidFill>
                        </a:rPr>
                        <a:t>Cytoplasmic translation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 marL="36000" marR="36000" marT="36000" marB="3600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chemeClr val="tx1"/>
                          </a:solidFill>
                        </a:rPr>
                        <a:t>5.6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 marL="36000" marR="36000" marT="36000" marB="3600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chemeClr val="tx1"/>
                          </a:solidFill>
                        </a:rPr>
                        <a:t>12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 marL="36000" marR="36000" marT="36000" marB="3600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76042004"/>
                  </a:ext>
                </a:extLst>
              </a:tr>
              <a:tr h="268826">
                <a:tc vMerge="1">
                  <a:txBody>
                    <a:bodyPr/>
                    <a:lstStyle/>
                    <a:p>
                      <a:pPr latinLnBrk="1"/>
                      <a:endParaRPr lang="ko-KR" altLang="en-US" dirty="0">
                        <a:solidFill>
                          <a:schemeClr val="bg1">
                            <a:lumMod val="65000"/>
                          </a:schemeClr>
                        </a:solidFill>
                      </a:endParaRPr>
                    </a:p>
                  </a:txBody>
                  <a:tcPr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chemeClr val="tx1"/>
                          </a:solidFill>
                        </a:rPr>
                        <a:t>rRNA metabolism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 marL="36000" marR="36000" marT="36000" marB="3600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chemeClr val="tx1"/>
                          </a:solidFill>
                        </a:rPr>
                        <a:t>3.8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 marL="36000" marR="36000" marT="36000" marB="3600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chemeClr val="tx1"/>
                          </a:solidFill>
                        </a:rPr>
                        <a:t>14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 marL="36000" marR="36000" marT="36000" marB="3600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28677629"/>
                  </a:ext>
                </a:extLst>
              </a:tr>
              <a:tr h="149523">
                <a:tc rowSpan="2">
                  <a:txBody>
                    <a:bodyPr/>
                    <a:lstStyle/>
                    <a:p>
                      <a:pPr algn="ctr" latinLnBrk="1"/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 marL="36000" marR="36000" marT="36000" marB="3600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chemeClr val="tx1"/>
                          </a:solidFill>
                        </a:rPr>
                        <a:t>61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 marL="36000" marR="36000" marT="36000" marB="3600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chemeClr val="tx1"/>
                          </a:solidFill>
                        </a:rPr>
                        <a:t>Chromosome organization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 marL="36000" marR="36000" marT="36000" marB="3600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chemeClr val="tx1"/>
                          </a:solidFill>
                        </a:rPr>
                        <a:t>5.7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 marL="36000" marR="36000" marT="36000" marB="3600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chemeClr val="tx1"/>
                          </a:solidFill>
                        </a:rPr>
                        <a:t>6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 marL="36000" marR="36000" marT="36000" marB="3600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84143734"/>
                  </a:ext>
                </a:extLst>
              </a:tr>
              <a:tr h="194700">
                <a:tc vMerge="1">
                  <a:txBody>
                    <a:bodyPr/>
                    <a:lstStyle/>
                    <a:p>
                      <a:pPr latinLnBrk="1"/>
                      <a:endParaRPr lang="ko-KR" altLang="en-US" dirty="0">
                        <a:solidFill>
                          <a:schemeClr val="bg1">
                            <a:lumMod val="65000"/>
                          </a:schemeClr>
                        </a:solidFill>
                      </a:endParaRPr>
                    </a:p>
                  </a:txBody>
                  <a:tcPr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chemeClr val="tx1"/>
                          </a:solidFill>
                        </a:rPr>
                        <a:t>RNA destabilization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 marL="36000" marR="36000" marT="36000" marB="3600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chemeClr val="tx1"/>
                          </a:solidFill>
                        </a:rPr>
                        <a:t>0.93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 marL="36000" marR="36000" marT="36000" marB="3600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chemeClr val="tx1"/>
                          </a:solidFill>
                        </a:rPr>
                        <a:t>7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 marL="36000" marR="36000" marT="36000" marB="3600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91544130"/>
                  </a:ext>
                </a:extLst>
              </a:tr>
              <a:tr h="149523">
                <a:tc rowSpan="2">
                  <a:txBody>
                    <a:bodyPr/>
                    <a:lstStyle/>
                    <a:p>
                      <a:pPr algn="ctr" latinLnBrk="1"/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 marL="36000" marR="36000" marT="36000" marB="3600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chemeClr val="tx1"/>
                          </a:solidFill>
                        </a:rPr>
                        <a:t>16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 marL="36000" marR="36000" marT="36000" marB="3600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chemeClr val="tx1"/>
                          </a:solidFill>
                        </a:rPr>
                        <a:t>Attachment of GPI anchor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 marL="36000" marR="36000" marT="36000" marB="3600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chemeClr val="tx1"/>
                          </a:solidFill>
                        </a:rPr>
                        <a:t>2.0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 marL="36000" marR="36000" marT="36000" marB="3600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chemeClr val="tx1"/>
                          </a:solidFill>
                        </a:rPr>
                        <a:t>2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 marL="36000" marR="36000" marT="36000" marB="3600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00564659"/>
                  </a:ext>
                </a:extLst>
              </a:tr>
              <a:tr h="118698">
                <a:tc vMerge="1">
                  <a:txBody>
                    <a:bodyPr/>
                    <a:lstStyle/>
                    <a:p>
                      <a:pPr latinLnBrk="1"/>
                      <a:endParaRPr lang="ko-KR" altLang="en-US" dirty="0">
                        <a:solidFill>
                          <a:schemeClr val="bg1">
                            <a:lumMod val="65000"/>
                          </a:schemeClr>
                        </a:solidFill>
                      </a:endParaRPr>
                    </a:p>
                  </a:txBody>
                  <a:tcPr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chemeClr val="tx1"/>
                          </a:solidFill>
                        </a:rPr>
                        <a:t>Phospholipid biosynthesis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 marL="36000" marR="36000" marT="36000" marB="3600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chemeClr val="tx1"/>
                          </a:solidFill>
                        </a:rPr>
                        <a:t>0.99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 marL="36000" marR="36000" marT="36000" marB="3600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chemeClr val="tx1"/>
                          </a:solidFill>
                        </a:rPr>
                        <a:t>7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 marL="36000" marR="36000" marT="36000" marB="3600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43484996"/>
                  </a:ext>
                </a:extLst>
              </a:tr>
              <a:tr h="330927">
                <a:tc>
                  <a:txBody>
                    <a:bodyPr/>
                    <a:lstStyle/>
                    <a:p>
                      <a:pPr algn="ctr" latinLnBrk="1"/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 marL="36000" marR="36000" marT="36000" marB="3600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chemeClr val="tx1"/>
                          </a:solidFill>
                        </a:rPr>
                        <a:t>15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 marL="36000" marR="36000" marT="36000" marB="3600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chemeClr val="tx1"/>
                          </a:solidFill>
                        </a:rPr>
                        <a:t>mRNA 3’-end processing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 marL="36000" marR="36000" marT="36000" marB="3600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chemeClr val="tx1"/>
                          </a:solidFill>
                        </a:rPr>
                        <a:t>4.4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 marL="36000" marR="36000" marT="36000" marB="3600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chemeClr val="tx1"/>
                          </a:solidFill>
                        </a:rPr>
                        <a:t>6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 marL="36000" marR="36000" marT="36000" marB="3600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95993525"/>
                  </a:ext>
                </a:extLst>
              </a:tr>
              <a:tr h="149523">
                <a:tc rowSpan="2">
                  <a:txBody>
                    <a:bodyPr/>
                    <a:lstStyle/>
                    <a:p>
                      <a:pPr algn="ctr" latinLnBrk="1"/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 marL="36000" marR="36000" marT="36000" marB="3600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000">
                          <a:solidFill>
                            <a:schemeClr val="tx1"/>
                          </a:solidFill>
                        </a:rPr>
                        <a:t>14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 marL="36000" marR="36000" marT="36000" marB="3600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chemeClr val="tx1"/>
                          </a:solidFill>
                        </a:rPr>
                        <a:t>Chromosome organization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 marL="36000" marR="36000" marT="36000" marB="3600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chemeClr val="tx1"/>
                          </a:solidFill>
                        </a:rPr>
                        <a:t>5.7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 marL="36000" marR="36000" marT="36000" marB="3600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chemeClr val="tx1"/>
                          </a:solidFill>
                        </a:rPr>
                        <a:t>2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 marL="36000" marR="36000" marT="36000" marB="3600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46478635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pPr latinLnBrk="1"/>
                      <a:endParaRPr lang="ko-KR" altLang="en-US" dirty="0">
                        <a:solidFill>
                          <a:schemeClr val="bg1">
                            <a:lumMod val="65000"/>
                          </a:schemeClr>
                        </a:solidFill>
                      </a:endParaRPr>
                    </a:p>
                  </a:txBody>
                  <a:tcPr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chemeClr val="tx1"/>
                          </a:solidFill>
                        </a:rPr>
                        <a:t>Spindle organization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 marL="36000" marR="36000" marT="36000" marB="3600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chemeClr val="tx1"/>
                          </a:solidFill>
                        </a:rPr>
                        <a:t>2.8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 marL="36000" marR="36000" marT="36000" marB="3600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chemeClr val="tx1"/>
                          </a:solidFill>
                        </a:rPr>
                        <a:t>6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 marL="36000" marR="36000" marT="36000" marB="3600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57596177"/>
                  </a:ext>
                </a:extLst>
              </a:tr>
              <a:tr h="149523">
                <a:tc rowSpan="2">
                  <a:txBody>
                    <a:bodyPr/>
                    <a:lstStyle/>
                    <a:p>
                      <a:pPr algn="ctr" latinLnBrk="1"/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 marL="36000" marR="36000" marT="36000" marB="3600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chemeClr val="tx1"/>
                          </a:solidFill>
                        </a:rPr>
                        <a:t>19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 marL="36000" marR="36000" marT="36000" marB="3600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chemeClr val="tx1"/>
                          </a:solidFill>
                        </a:rPr>
                        <a:t>Secondary metabolic process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 marL="36000" marR="36000" marT="36000" marB="3600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chemeClr val="tx1"/>
                          </a:solidFill>
                        </a:rPr>
                        <a:t>3.2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 marL="36000" marR="36000" marT="36000" marB="3600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chemeClr val="tx1"/>
                          </a:solidFill>
                        </a:rPr>
                        <a:t>1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 marL="36000" marR="36000" marT="36000" marB="3600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53535870"/>
                  </a:ext>
                </a:extLst>
              </a:tr>
              <a:tr h="149523">
                <a:tc vMerge="1">
                  <a:txBody>
                    <a:bodyPr/>
                    <a:lstStyle/>
                    <a:p>
                      <a:pPr latinLnBrk="1"/>
                      <a:endParaRPr lang="ko-KR" altLang="en-US" dirty="0">
                        <a:solidFill>
                          <a:schemeClr val="bg1">
                            <a:lumMod val="65000"/>
                          </a:schemeClr>
                        </a:solidFill>
                      </a:endParaRPr>
                    </a:p>
                  </a:txBody>
                  <a:tcPr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chemeClr val="tx1"/>
                          </a:solidFill>
                        </a:rPr>
                        <a:t>Olefinic compound metabolism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 marL="36000" marR="36000" marT="36000" marB="3600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chemeClr val="tx1"/>
                          </a:solidFill>
                        </a:rPr>
                        <a:t>2.0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 marL="36000" marR="36000" marT="36000" marB="3600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chemeClr val="tx1"/>
                          </a:solidFill>
                        </a:rPr>
                        <a:t>6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 marL="36000" marR="36000" marT="36000" marB="3600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60460945"/>
                  </a:ext>
                </a:extLst>
              </a:tr>
              <a:tr h="299046">
                <a:tc>
                  <a:txBody>
                    <a:bodyPr/>
                    <a:lstStyle/>
                    <a:p>
                      <a:pPr algn="ctr" latinLnBrk="1"/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 marL="36000" marR="36000" marT="36000" marB="3600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chemeClr val="tx1"/>
                          </a:solidFill>
                        </a:rPr>
                        <a:t>32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 marL="36000" marR="36000" marT="36000" marB="3600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chemeClr val="tx1"/>
                          </a:solidFill>
                        </a:rPr>
                        <a:t>Membrane permeability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 marL="36000" marR="36000" marT="36000" marB="3600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chemeClr val="tx1"/>
                          </a:solidFill>
                        </a:rPr>
                        <a:t>4.6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 marL="36000" marR="36000" marT="36000" marB="3600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chemeClr val="tx1"/>
                          </a:solidFill>
                        </a:rPr>
                        <a:t>5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 marL="36000" marR="36000" marT="36000" marB="3600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32021672"/>
                  </a:ext>
                </a:extLst>
              </a:tr>
              <a:tr h="299046">
                <a:tc>
                  <a:txBody>
                    <a:bodyPr/>
                    <a:lstStyle/>
                    <a:p>
                      <a:pPr algn="ctr" latinLnBrk="1"/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 marL="36000" marR="36000" marT="36000" marB="3600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chemeClr val="tx1"/>
                          </a:solidFill>
                        </a:rPr>
                        <a:t>9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 marL="36000" marR="36000" marT="36000" marB="3600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chemeClr val="tx1"/>
                          </a:solidFill>
                        </a:rPr>
                        <a:t>Proteolysis 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 marL="36000" marR="36000" marT="36000" marB="3600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chemeClr val="tx1"/>
                          </a:solidFill>
                        </a:rPr>
                        <a:t>3.4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 marL="36000" marR="36000" marT="36000" marB="3600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chemeClr val="tx1"/>
                          </a:solidFill>
                        </a:rPr>
                        <a:t>5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 marL="36000" marR="36000" marT="36000" marB="3600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77640863"/>
                  </a:ext>
                </a:extLst>
              </a:tr>
              <a:tr h="149523">
                <a:tc rowSpan="2">
                  <a:txBody>
                    <a:bodyPr/>
                    <a:lstStyle/>
                    <a:p>
                      <a:pPr algn="ctr" latinLnBrk="1"/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 marL="36000" marR="36000" marT="36000" marB="3600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chemeClr val="tx1"/>
                          </a:solidFill>
                        </a:rPr>
                        <a:t>2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 marL="36000" marR="36000" marT="36000" marB="3600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chemeClr val="tx1"/>
                          </a:solidFill>
                        </a:rPr>
                        <a:t>Signaling pathway in spinal cord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 marL="36000" marR="36000" marT="36000" marB="3600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chemeClr val="tx1"/>
                          </a:solidFill>
                        </a:rPr>
                        <a:t>0.72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 marL="36000" marR="36000" marT="36000" marB="3600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chemeClr val="tx1"/>
                          </a:solidFill>
                        </a:rPr>
                        <a:t>1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 marL="36000" marR="36000" marT="36000" marB="3600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5821267"/>
                  </a:ext>
                </a:extLst>
              </a:tr>
              <a:tr h="149523">
                <a:tc vMerge="1">
                  <a:txBody>
                    <a:bodyPr/>
                    <a:lstStyle/>
                    <a:p>
                      <a:pPr latinLnBrk="1"/>
                      <a:endParaRPr lang="ko-KR" altLang="en-US" dirty="0">
                        <a:solidFill>
                          <a:schemeClr val="bg1">
                            <a:lumMod val="65000"/>
                          </a:schemeClr>
                        </a:solidFill>
                      </a:endParaRPr>
                    </a:p>
                  </a:txBody>
                  <a:tcPr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chemeClr val="tx1"/>
                          </a:solidFill>
                        </a:rPr>
                        <a:t>Signaling pathway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 marL="36000" marR="36000" marT="36000" marB="3600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chemeClr val="tx1"/>
                          </a:solidFill>
                        </a:rPr>
                        <a:t>0.55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 marL="36000" marR="36000" marT="36000" marB="3600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chemeClr val="tx1"/>
                          </a:solidFill>
                        </a:rPr>
                        <a:t>4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 marL="36000" marR="36000" marT="36000" marB="36000" anchor="ctr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91886301"/>
                  </a:ext>
                </a:extLst>
              </a:tr>
            </a:tbl>
          </a:graphicData>
        </a:graphic>
      </p:graphicFrame>
      <p:sp>
        <p:nvSpPr>
          <p:cNvPr id="32" name="제목 2">
            <a:extLst>
              <a:ext uri="{FF2B5EF4-FFF2-40B4-BE49-F238E27FC236}">
                <a16:creationId xmlns:a16="http://schemas.microsoft.com/office/drawing/2014/main" id="{7E6A3B6D-D266-D62C-0498-66827365AE3E}"/>
              </a:ext>
            </a:extLst>
          </p:cNvPr>
          <p:cNvSpPr txBox="1">
            <a:spLocks/>
          </p:cNvSpPr>
          <p:nvPr/>
        </p:nvSpPr>
        <p:spPr>
          <a:xfrm>
            <a:off x="672374" y="575463"/>
            <a:ext cx="5680801" cy="1204224"/>
          </a:xfrm>
          <a:prstGeom prst="rect">
            <a:avLst/>
          </a:prstGeom>
        </p:spPr>
        <p:txBody>
          <a:bodyPr vert="horz" lIns="91440" tIns="45721" rIns="91440" bIns="45721" rtlCol="0" anchor="t">
            <a:no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2400" b="1" kern="1200">
                <a:solidFill>
                  <a:schemeClr val="tx1"/>
                </a:solidFill>
                <a:latin typeface="Arial" panose="020B0604020202020204" pitchFamily="34" charset="0"/>
                <a:ea typeface="+mj-ea"/>
                <a:cs typeface="Arial" panose="020B0604020202020204" pitchFamily="34" charset="0"/>
              </a:defRPr>
            </a:lvl1pPr>
          </a:lstStyle>
          <a:p>
            <a:pPr algn="just">
              <a:lnSpc>
                <a:spcPct val="150000"/>
              </a:lnSpc>
            </a:pPr>
            <a:r>
              <a:rPr lang="en-US" altLang="ko-KR" sz="1050" dirty="0"/>
              <a:t>Supplementary Table 1. Contribution of representative vs. dominant GOBP terms to TP53 target networks</a:t>
            </a:r>
            <a:r>
              <a:rPr lang="en-US" altLang="ko-KR" sz="1050" b="0" dirty="0"/>
              <a:t>. </a:t>
            </a:r>
            <a:r>
              <a:rPr lang="en-US" altLang="ko-KR" sz="1050" b="0" dirty="0">
                <a:solidFill>
                  <a:prstClr val="black"/>
                </a:solidFill>
              </a:rPr>
              <a:t>The TP53 target network from Figure 2A was decomposed using</a:t>
            </a:r>
            <a:r>
              <a:rPr lang="en-US" altLang="ko-KR" sz="1050" b="0" dirty="0"/>
              <a:t> </a:t>
            </a:r>
            <a:r>
              <a:rPr lang="en-US" altLang="ko-KR" sz="1050" b="0" i="1" dirty="0">
                <a:solidFill>
                  <a:prstClr val="black"/>
                </a:solidFill>
              </a:rPr>
              <a:t>Tw </a:t>
            </a:r>
            <a:r>
              <a:rPr lang="en-US" altLang="ko-KR" sz="1050" b="0" dirty="0">
                <a:solidFill>
                  <a:prstClr val="black"/>
                </a:solidFill>
              </a:rPr>
              <a:t>&gt; 0.3 (top 5% edges), resulting in 9 subnetworks with more than 3 nodes. Representative terms refer to those with the highest –log (p-value), while dominant terms are defined by the largest number of associated genes in each network.</a:t>
            </a:r>
          </a:p>
        </p:txBody>
      </p:sp>
    </p:spTree>
    <p:extLst>
      <p:ext uri="{BB962C8B-B14F-4D97-AF65-F5344CB8AC3E}">
        <p14:creationId xmlns:p14="http://schemas.microsoft.com/office/powerpoint/2010/main" val="1303693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2">
            <a:extLst>
              <a:ext uri="{FF2B5EF4-FFF2-40B4-BE49-F238E27FC236}">
                <a16:creationId xmlns:a16="http://schemas.microsoft.com/office/drawing/2014/main" id="{267CA03D-919B-4EA9-805E-963DCBBD67C8}"/>
              </a:ext>
            </a:extLst>
          </p:cNvPr>
          <p:cNvSpPr txBox="1">
            <a:spLocks/>
          </p:cNvSpPr>
          <p:nvPr/>
        </p:nvSpPr>
        <p:spPr>
          <a:xfrm>
            <a:off x="330739" y="69625"/>
            <a:ext cx="5938661" cy="1613260"/>
          </a:xfrm>
          <a:prstGeom prst="rect">
            <a:avLst/>
          </a:prstGeom>
        </p:spPr>
        <p:txBody>
          <a:bodyPr vert="horz" lIns="91440" tIns="45721" rIns="91440" bIns="45721" rtlCol="0" anchor="t">
            <a:noAutofit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2400" b="1" kern="1200">
                <a:solidFill>
                  <a:schemeClr val="tx1"/>
                </a:solidFill>
                <a:latin typeface="Arial" panose="020B0604020202020204" pitchFamily="34" charset="0"/>
                <a:ea typeface="+mj-ea"/>
                <a:cs typeface="Arial" panose="020B0604020202020204" pitchFamily="34" charset="0"/>
              </a:defRPr>
            </a:lvl1pPr>
          </a:lstStyle>
          <a:p>
            <a:pPr algn="just">
              <a:lnSpc>
                <a:spcPct val="150000"/>
              </a:lnSpc>
            </a:pPr>
            <a:r>
              <a:rPr lang="en-US" altLang="ko-KR" sz="1050" dirty="0"/>
              <a:t>Supplementary Table 2. Comparison of </a:t>
            </a:r>
            <a:r>
              <a:rPr lang="en-US" altLang="ko-KR" sz="1050" dirty="0" err="1"/>
              <a:t>NetCrafter</a:t>
            </a:r>
            <a:r>
              <a:rPr lang="en-US" altLang="ko-KR" sz="1050" dirty="0"/>
              <a:t> with commonly used network tools. </a:t>
            </a:r>
            <a:r>
              <a:rPr lang="en-US" altLang="ko-KR" sz="1050" b="0" dirty="0"/>
              <a:t>This table summarizes key conceptual and functional differences among </a:t>
            </a:r>
            <a:r>
              <a:rPr lang="en-US" altLang="ko-KR" sz="1050" b="0" dirty="0" err="1"/>
              <a:t>NetCrafter</a:t>
            </a:r>
            <a:r>
              <a:rPr lang="en-US" altLang="ko-KR" sz="1050" b="0" dirty="0"/>
              <a:t>, </a:t>
            </a:r>
            <a:r>
              <a:rPr lang="en-US" altLang="ko-KR" sz="1050" b="0" dirty="0" err="1"/>
              <a:t>GeneMANIA</a:t>
            </a:r>
            <a:r>
              <a:rPr lang="en-US" altLang="ko-KR" sz="1050" b="0" dirty="0"/>
              <a:t>, </a:t>
            </a:r>
            <a:r>
              <a:rPr lang="en-US" altLang="ko-KR" sz="1050" b="0" dirty="0" err="1"/>
              <a:t>WGCNA</a:t>
            </a:r>
            <a:r>
              <a:rPr lang="en-US" altLang="ko-KR" sz="1050" b="0" dirty="0"/>
              <a:t>, and ontology-based modules available in </a:t>
            </a:r>
            <a:r>
              <a:rPr lang="en-US" altLang="ko-KR" sz="1050" b="0" dirty="0" err="1"/>
              <a:t>Cytoscape</a:t>
            </a:r>
            <a:r>
              <a:rPr lang="en-US" altLang="ko-KR" sz="1050" b="0" dirty="0"/>
              <a:t>. The </a:t>
            </a:r>
            <a:r>
              <a:rPr lang="en-US" altLang="ko-KR" sz="1050" b="0" dirty="0" err="1"/>
              <a:t>Cytoscape</a:t>
            </a:r>
            <a:r>
              <a:rPr lang="en-US" altLang="ko-KR" sz="1050" b="0" dirty="0"/>
              <a:t> category refers to widely used applications such as </a:t>
            </a:r>
            <a:r>
              <a:rPr lang="en-US" altLang="ko-KR" sz="1050" b="0" dirty="0" err="1"/>
              <a:t>BiNGO</a:t>
            </a:r>
            <a:r>
              <a:rPr lang="en-US" altLang="ko-KR" sz="1050" b="0" dirty="0"/>
              <a:t> [1], </a:t>
            </a:r>
            <a:r>
              <a:rPr lang="en-US" altLang="ko-KR" sz="1050" b="0" dirty="0" err="1"/>
              <a:t>ClueGO</a:t>
            </a:r>
            <a:r>
              <a:rPr lang="en-US" altLang="ko-KR" sz="1050" b="0" dirty="0"/>
              <a:t> [2], and </a:t>
            </a:r>
            <a:r>
              <a:rPr lang="en-US" altLang="ko-KR" sz="1050" b="0" dirty="0" err="1"/>
              <a:t>EnrichmentMap</a:t>
            </a:r>
            <a:r>
              <a:rPr lang="en-US" altLang="ko-KR" sz="1050" b="0" dirty="0"/>
              <a:t> [3], which construct ontology-term networks based on gene-overlap similarity rather than ontology-weighted gene–gene similarity. </a:t>
            </a:r>
          </a:p>
        </p:txBody>
      </p:sp>
      <p:graphicFrame>
        <p:nvGraphicFramePr>
          <p:cNvPr id="3" name="표 2">
            <a:extLst>
              <a:ext uri="{FF2B5EF4-FFF2-40B4-BE49-F238E27FC236}">
                <a16:creationId xmlns:a16="http://schemas.microsoft.com/office/drawing/2014/main" id="{49501A5F-13E7-4D13-B907-28DD968C7B6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76001918"/>
              </p:ext>
            </p:extLst>
          </p:nvPr>
        </p:nvGraphicFramePr>
        <p:xfrm>
          <a:off x="330741" y="1754809"/>
          <a:ext cx="5938661" cy="5424173"/>
        </p:xfrm>
        <a:graphic>
          <a:graphicData uri="http://schemas.openxmlformats.org/drawingml/2006/table">
            <a:tbl>
              <a:tblPr/>
              <a:tblGrid>
                <a:gridCol w="1428788">
                  <a:extLst>
                    <a:ext uri="{9D8B030D-6E8A-4147-A177-3AD203B41FA5}">
                      <a16:colId xmlns:a16="http://schemas.microsoft.com/office/drawing/2014/main" val="2505770917"/>
                    </a:ext>
                  </a:extLst>
                </a:gridCol>
                <a:gridCol w="1498242">
                  <a:extLst>
                    <a:ext uri="{9D8B030D-6E8A-4147-A177-3AD203B41FA5}">
                      <a16:colId xmlns:a16="http://schemas.microsoft.com/office/drawing/2014/main" val="1853599328"/>
                    </a:ext>
                  </a:extLst>
                </a:gridCol>
                <a:gridCol w="1051383">
                  <a:extLst>
                    <a:ext uri="{9D8B030D-6E8A-4147-A177-3AD203B41FA5}">
                      <a16:colId xmlns:a16="http://schemas.microsoft.com/office/drawing/2014/main" val="3828341809"/>
                    </a:ext>
                  </a:extLst>
                </a:gridCol>
                <a:gridCol w="980124">
                  <a:extLst>
                    <a:ext uri="{9D8B030D-6E8A-4147-A177-3AD203B41FA5}">
                      <a16:colId xmlns:a16="http://schemas.microsoft.com/office/drawing/2014/main" val="2038695238"/>
                    </a:ext>
                  </a:extLst>
                </a:gridCol>
                <a:gridCol w="980124">
                  <a:extLst>
                    <a:ext uri="{9D8B030D-6E8A-4147-A177-3AD203B41FA5}">
                      <a16:colId xmlns:a16="http://schemas.microsoft.com/office/drawing/2014/main" val="3163481947"/>
                    </a:ext>
                  </a:extLst>
                </a:gridCol>
              </a:tblGrid>
              <a:tr h="337540">
                <a:tc>
                  <a:txBody>
                    <a:bodyPr/>
                    <a:lstStyle/>
                    <a:p>
                      <a:r>
                        <a:rPr lang="en-US" sz="1000" b="1" dirty="0"/>
                        <a:t>Feature / Method</a:t>
                      </a:r>
                    </a:p>
                  </a:txBody>
                  <a:tcPr marL="71623" marR="71623" marT="35811" marB="35811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b="1" dirty="0" err="1"/>
                        <a:t>NetCrafter</a:t>
                      </a:r>
                      <a:endParaRPr lang="en-US" sz="1000" b="1" dirty="0"/>
                    </a:p>
                  </a:txBody>
                  <a:tcPr marL="71623" marR="71623" marT="35811" marB="35811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b="1" dirty="0" err="1"/>
                        <a:t>GeneMANIA</a:t>
                      </a:r>
                      <a:endParaRPr lang="en-US" sz="1000" b="1" dirty="0"/>
                    </a:p>
                  </a:txBody>
                  <a:tcPr marL="71623" marR="71623" marT="35811" marB="35811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b="1" dirty="0" err="1"/>
                        <a:t>WGCNA</a:t>
                      </a:r>
                      <a:endParaRPr lang="en-US" sz="1000" b="1" dirty="0"/>
                    </a:p>
                  </a:txBody>
                  <a:tcPr marL="71623" marR="71623" marT="35811" marB="35811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atinLnBrk="0"/>
                      <a:r>
                        <a:rPr lang="en-US" sz="1000" b="1" dirty="0" err="1"/>
                        <a:t>Cytoscape</a:t>
                      </a:r>
                      <a:r>
                        <a:rPr lang="en-US" sz="1000" b="1" dirty="0"/>
                        <a:t> Ontology Tools</a:t>
                      </a:r>
                    </a:p>
                  </a:txBody>
                  <a:tcPr marL="71623" marR="71623" marT="35811" marB="35811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95069671"/>
                  </a:ext>
                </a:extLst>
              </a:tr>
              <a:tr h="751793">
                <a:tc>
                  <a:txBody>
                    <a:bodyPr/>
                    <a:lstStyle/>
                    <a:p>
                      <a:pPr latinLnBrk="0"/>
                      <a:r>
                        <a:rPr lang="en-US" sz="1000" baseline="0" dirty="0"/>
                        <a:t>Network basis</a:t>
                      </a:r>
                    </a:p>
                  </a:txBody>
                  <a:tcPr marL="71623" marR="71623" marT="35811" marB="35811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atinLnBrk="0"/>
                      <a:r>
                        <a:rPr lang="en-US" sz="1000" b="1" baseline="0" dirty="0"/>
                        <a:t>Ontology-weighted semantic similarity (Tw)</a:t>
                      </a:r>
                      <a:r>
                        <a:rPr lang="en-US" sz="1000" baseline="0" dirty="0"/>
                        <a:t> based on p-values</a:t>
                      </a:r>
                    </a:p>
                  </a:txBody>
                  <a:tcPr marL="71623" marR="71623" marT="35811" marB="35811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atinLnBrk="0"/>
                      <a:r>
                        <a:rPr lang="en-US" sz="1000" baseline="0" dirty="0"/>
                        <a:t>Template-based association networks</a:t>
                      </a:r>
                    </a:p>
                  </a:txBody>
                  <a:tcPr marL="71623" marR="71623" marT="35811" marB="35811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atinLnBrk="0"/>
                      <a:r>
                        <a:rPr lang="en-US" sz="1000" baseline="0" dirty="0"/>
                        <a:t>Correlation-based (co-expression)</a:t>
                      </a:r>
                    </a:p>
                  </a:txBody>
                  <a:tcPr marL="71623" marR="71623" marT="35811" marB="35811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atinLnBrk="0"/>
                      <a:r>
                        <a:rPr lang="en-US" sz="1000" baseline="0" dirty="0"/>
                        <a:t>Term overlap (</a:t>
                      </a:r>
                      <a:r>
                        <a:rPr lang="en-US" sz="1000" baseline="0" dirty="0" err="1"/>
                        <a:t>Tanimoto</a:t>
                      </a:r>
                      <a:r>
                        <a:rPr lang="en-US" sz="1000" baseline="0" dirty="0"/>
                        <a:t>)</a:t>
                      </a:r>
                    </a:p>
                  </a:txBody>
                  <a:tcPr marL="71623" marR="71623" marT="35811" marB="35811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12167387"/>
                  </a:ext>
                </a:extLst>
              </a:tr>
              <a:tr h="613708">
                <a:tc>
                  <a:txBody>
                    <a:bodyPr/>
                    <a:lstStyle/>
                    <a:p>
                      <a:pPr latinLnBrk="0"/>
                      <a:r>
                        <a:rPr lang="en-US" sz="1000" baseline="0" dirty="0"/>
                        <a:t>Context specificity</a:t>
                      </a:r>
                    </a:p>
                  </a:txBody>
                  <a:tcPr marL="71623" marR="71623" marT="35811" marB="35811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atinLnBrk="0"/>
                      <a:r>
                        <a:rPr lang="en-US" sz="1000" b="1" baseline="0" dirty="0"/>
                        <a:t>High</a:t>
                      </a:r>
                      <a:r>
                        <a:rPr lang="en-US" sz="1000" baseline="0" dirty="0"/>
                        <a:t> (network changes per gene list via Tw)</a:t>
                      </a:r>
                    </a:p>
                  </a:txBody>
                  <a:tcPr marL="71623" marR="71623" marT="35811" marB="35811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atinLnBrk="0"/>
                      <a:r>
                        <a:rPr lang="en-US" sz="1000" baseline="0"/>
                        <a:t>Low–Moderate</a:t>
                      </a:r>
                    </a:p>
                  </a:txBody>
                  <a:tcPr marL="71623" marR="71623" marT="35811" marB="35811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atinLnBrk="0"/>
                      <a:r>
                        <a:rPr lang="en-US" sz="1000" baseline="0" dirty="0"/>
                        <a:t>Low (same expression matrix)</a:t>
                      </a:r>
                    </a:p>
                  </a:txBody>
                  <a:tcPr marL="71623" marR="71623" marT="35811" marB="35811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atinLnBrk="0"/>
                      <a:r>
                        <a:rPr lang="en-US" sz="1000" baseline="0" dirty="0"/>
                        <a:t>Moderate</a:t>
                      </a:r>
                    </a:p>
                  </a:txBody>
                  <a:tcPr marL="71623" marR="71623" marT="35811" marB="35811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35152282"/>
                  </a:ext>
                </a:extLst>
              </a:tr>
              <a:tr h="751793">
                <a:tc>
                  <a:txBody>
                    <a:bodyPr/>
                    <a:lstStyle/>
                    <a:p>
                      <a:pPr latinLnBrk="0"/>
                      <a:r>
                        <a:rPr lang="en-US" sz="1000" baseline="0" dirty="0"/>
                        <a:t>Ability to decompose subnetworks by similarity threshold</a:t>
                      </a:r>
                    </a:p>
                  </a:txBody>
                  <a:tcPr marL="71623" marR="71623" marT="35811" marB="35811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atinLnBrk="0"/>
                      <a:r>
                        <a:rPr lang="en-US" sz="1000" b="1" baseline="0" dirty="0"/>
                        <a:t>Yes (Tw thresholding)</a:t>
                      </a:r>
                      <a:endParaRPr lang="en-US" sz="1000" baseline="0" dirty="0"/>
                    </a:p>
                  </a:txBody>
                  <a:tcPr marL="71623" marR="71623" marT="35811" marB="35811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atinLnBrk="0"/>
                      <a:r>
                        <a:rPr lang="en-US" sz="1000" baseline="0"/>
                        <a:t>No</a:t>
                      </a:r>
                    </a:p>
                  </a:txBody>
                  <a:tcPr marL="71623" marR="71623" marT="35811" marB="35811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atinLnBrk="0"/>
                      <a:r>
                        <a:rPr lang="en-US" sz="1000" baseline="0" dirty="0"/>
                        <a:t>Limited</a:t>
                      </a:r>
                    </a:p>
                  </a:txBody>
                  <a:tcPr marL="71623" marR="71623" marT="35811" marB="35811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atinLnBrk="0"/>
                      <a:r>
                        <a:rPr lang="en-US" sz="1000" baseline="0" dirty="0"/>
                        <a:t>No</a:t>
                      </a:r>
                    </a:p>
                  </a:txBody>
                  <a:tcPr marL="71623" marR="71623" marT="35811" marB="35811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51297540"/>
                  </a:ext>
                </a:extLst>
              </a:tr>
              <a:tr h="613708">
                <a:tc>
                  <a:txBody>
                    <a:bodyPr/>
                    <a:lstStyle/>
                    <a:p>
                      <a:pPr latinLnBrk="0"/>
                      <a:r>
                        <a:rPr lang="en-US" sz="1000" baseline="0" dirty="0"/>
                        <a:t>Uses enrichment p-values as quantitative weights</a:t>
                      </a:r>
                    </a:p>
                  </a:txBody>
                  <a:tcPr marL="71623" marR="71623" marT="35811" marB="35811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atinLnBrk="0"/>
                      <a:r>
                        <a:rPr lang="en-US" sz="1000" b="1" baseline="0" dirty="0"/>
                        <a:t>Yes</a:t>
                      </a:r>
                      <a:endParaRPr lang="en-US" sz="1000" baseline="0" dirty="0"/>
                    </a:p>
                  </a:txBody>
                  <a:tcPr marL="71623" marR="71623" marT="35811" marB="35811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atinLnBrk="0"/>
                      <a:r>
                        <a:rPr lang="en-US" sz="1000" baseline="0" dirty="0"/>
                        <a:t>No</a:t>
                      </a:r>
                    </a:p>
                  </a:txBody>
                  <a:tcPr marL="71623" marR="71623" marT="35811" marB="35811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atinLnBrk="0"/>
                      <a:r>
                        <a:rPr lang="en-US" sz="1000" baseline="0" dirty="0"/>
                        <a:t>No</a:t>
                      </a:r>
                    </a:p>
                  </a:txBody>
                  <a:tcPr marL="71623" marR="71623" marT="35811" marB="35811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atinLnBrk="0"/>
                      <a:r>
                        <a:rPr lang="en-US" sz="1000" baseline="0" dirty="0"/>
                        <a:t>No</a:t>
                      </a:r>
                    </a:p>
                  </a:txBody>
                  <a:tcPr marL="71623" marR="71623" marT="35811" marB="35811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14348620"/>
                  </a:ext>
                </a:extLst>
              </a:tr>
              <a:tr h="613708">
                <a:tc>
                  <a:txBody>
                    <a:bodyPr/>
                    <a:lstStyle/>
                    <a:p>
                      <a:pPr latinLnBrk="0"/>
                      <a:r>
                        <a:rPr lang="en-US" sz="1000" baseline="0" dirty="0"/>
                        <a:t>Identifies functional hotspots (high Tw nodes)</a:t>
                      </a:r>
                    </a:p>
                  </a:txBody>
                  <a:tcPr marL="71623" marR="71623" marT="35811" marB="35811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atinLnBrk="0"/>
                      <a:r>
                        <a:rPr lang="en-US" sz="1000" b="1" baseline="0" dirty="0"/>
                        <a:t>Yes</a:t>
                      </a:r>
                      <a:endParaRPr lang="en-US" sz="1000" baseline="0" dirty="0"/>
                    </a:p>
                  </a:txBody>
                  <a:tcPr marL="71623" marR="71623" marT="35811" marB="35811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atinLnBrk="0"/>
                      <a:r>
                        <a:rPr lang="en-US" sz="1000" baseline="0" dirty="0"/>
                        <a:t>Limited</a:t>
                      </a:r>
                    </a:p>
                  </a:txBody>
                  <a:tcPr marL="71623" marR="71623" marT="35811" marB="35811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atinLnBrk="0"/>
                      <a:r>
                        <a:rPr lang="en-US" sz="1000" baseline="0" dirty="0"/>
                        <a:t>Limited</a:t>
                      </a:r>
                    </a:p>
                  </a:txBody>
                  <a:tcPr marL="71623" marR="71623" marT="35811" marB="35811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atinLnBrk="0"/>
                      <a:r>
                        <a:rPr lang="en-US" sz="1000" baseline="0" dirty="0"/>
                        <a:t>No</a:t>
                      </a:r>
                    </a:p>
                  </a:txBody>
                  <a:tcPr marL="71623" marR="71623" marT="35811" marB="35811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99225689"/>
                  </a:ext>
                </a:extLst>
              </a:tr>
              <a:tr h="613708">
                <a:tc>
                  <a:txBody>
                    <a:bodyPr/>
                    <a:lstStyle/>
                    <a:p>
                      <a:pPr latinLnBrk="0"/>
                      <a:r>
                        <a:rPr lang="en-US" sz="1000" baseline="0" dirty="0"/>
                        <a:t>Multi-list consensus analysis (p-value combination)</a:t>
                      </a:r>
                    </a:p>
                  </a:txBody>
                  <a:tcPr marL="71623" marR="71623" marT="35811" marB="35811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atinLnBrk="0"/>
                      <a:r>
                        <a:rPr lang="en-US" sz="1000" b="1" baseline="0" dirty="0"/>
                        <a:t>Yes</a:t>
                      </a:r>
                      <a:endParaRPr lang="en-US" sz="1000" baseline="0" dirty="0"/>
                    </a:p>
                  </a:txBody>
                  <a:tcPr marL="71623" marR="71623" marT="35811" marB="35811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atinLnBrk="0"/>
                      <a:r>
                        <a:rPr lang="en-US" sz="1000" baseline="0" dirty="0"/>
                        <a:t>No</a:t>
                      </a:r>
                    </a:p>
                  </a:txBody>
                  <a:tcPr marL="71623" marR="71623" marT="35811" marB="35811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atinLnBrk="0"/>
                      <a:r>
                        <a:rPr lang="en-US" sz="1000" baseline="0" dirty="0"/>
                        <a:t>No</a:t>
                      </a:r>
                    </a:p>
                  </a:txBody>
                  <a:tcPr marL="71623" marR="71623" marT="35811" marB="35811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atinLnBrk="0"/>
                      <a:r>
                        <a:rPr lang="en-US" sz="1000" baseline="0" dirty="0"/>
                        <a:t>No</a:t>
                      </a:r>
                    </a:p>
                  </a:txBody>
                  <a:tcPr marL="71623" marR="71623" marT="35811" marB="35811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6642915"/>
                  </a:ext>
                </a:extLst>
              </a:tr>
              <a:tr h="475625">
                <a:tc>
                  <a:txBody>
                    <a:bodyPr/>
                    <a:lstStyle/>
                    <a:p>
                      <a:pPr latinLnBrk="0"/>
                      <a:r>
                        <a:rPr lang="en-US" sz="1000" baseline="0" dirty="0"/>
                        <a:t>Dynamic subnetwork extraction</a:t>
                      </a:r>
                    </a:p>
                  </a:txBody>
                  <a:tcPr marL="71623" marR="71623" marT="35811" marB="35811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atinLnBrk="0"/>
                      <a:r>
                        <a:rPr lang="en-US" sz="1000" b="1" baseline="0" dirty="0"/>
                        <a:t>Fully automated</a:t>
                      </a:r>
                      <a:endParaRPr lang="en-US" sz="1000" baseline="0" dirty="0"/>
                    </a:p>
                  </a:txBody>
                  <a:tcPr marL="71623" marR="71623" marT="35811" marB="35811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atinLnBrk="0"/>
                      <a:r>
                        <a:rPr lang="en-US" sz="1000" baseline="0" dirty="0"/>
                        <a:t>No</a:t>
                      </a:r>
                    </a:p>
                  </a:txBody>
                  <a:tcPr marL="71623" marR="71623" marT="35811" marB="35811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atinLnBrk="0"/>
                      <a:r>
                        <a:rPr lang="en-US" sz="1000" baseline="0" dirty="0"/>
                        <a:t>Manual</a:t>
                      </a:r>
                    </a:p>
                  </a:txBody>
                  <a:tcPr marL="71623" marR="71623" marT="35811" marB="35811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atinLnBrk="0"/>
                      <a:r>
                        <a:rPr lang="en-US" sz="1000" baseline="0" dirty="0"/>
                        <a:t>Minimal</a:t>
                      </a:r>
                    </a:p>
                  </a:txBody>
                  <a:tcPr marL="71623" marR="71623" marT="35811" marB="35811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08347027"/>
                  </a:ext>
                </a:extLst>
              </a:tr>
              <a:tr h="613708">
                <a:tc>
                  <a:txBody>
                    <a:bodyPr/>
                    <a:lstStyle/>
                    <a:p>
                      <a:pPr latinLnBrk="0"/>
                      <a:r>
                        <a:rPr lang="en-US" sz="1000" baseline="0" dirty="0"/>
                        <a:t>Designed for heterogeneous omics integration</a:t>
                      </a:r>
                    </a:p>
                  </a:txBody>
                  <a:tcPr marL="71623" marR="71623" marT="35811" marB="35811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atinLnBrk="0"/>
                      <a:r>
                        <a:rPr lang="en-US" sz="1000" b="1" baseline="0" dirty="0"/>
                        <a:t>Yes</a:t>
                      </a:r>
                      <a:endParaRPr lang="en-US" sz="1000" baseline="0" dirty="0"/>
                    </a:p>
                  </a:txBody>
                  <a:tcPr marL="71623" marR="71623" marT="35811" marB="35811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atinLnBrk="0"/>
                      <a:r>
                        <a:rPr lang="en-US" sz="1000" baseline="0" dirty="0"/>
                        <a:t>No</a:t>
                      </a:r>
                    </a:p>
                  </a:txBody>
                  <a:tcPr marL="71623" marR="71623" marT="35811" marB="35811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atinLnBrk="0"/>
                      <a:r>
                        <a:rPr lang="en-US" sz="1000" baseline="0" dirty="0"/>
                        <a:t>No</a:t>
                      </a:r>
                    </a:p>
                  </a:txBody>
                  <a:tcPr marL="71623" marR="71623" marT="35811" marB="35811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atinLnBrk="0"/>
                      <a:r>
                        <a:rPr lang="en-US" sz="1000" baseline="0" dirty="0"/>
                        <a:t>Partially</a:t>
                      </a:r>
                    </a:p>
                  </a:txBody>
                  <a:tcPr marL="71623" marR="71623" marT="35811" marB="35811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64427053"/>
                  </a:ext>
                </a:extLst>
              </a:tr>
            </a:tbl>
          </a:graphicData>
        </a:graphic>
      </p:graphicFrame>
      <p:sp>
        <p:nvSpPr>
          <p:cNvPr id="5" name="직사각형 4">
            <a:extLst>
              <a:ext uri="{FF2B5EF4-FFF2-40B4-BE49-F238E27FC236}">
                <a16:creationId xmlns:a16="http://schemas.microsoft.com/office/drawing/2014/main" id="{0A4B50A7-FAC5-4642-88D3-6990AEB35F22}"/>
              </a:ext>
            </a:extLst>
          </p:cNvPr>
          <p:cNvSpPr/>
          <p:nvPr/>
        </p:nvSpPr>
        <p:spPr>
          <a:xfrm>
            <a:off x="330741" y="7250906"/>
            <a:ext cx="5938659" cy="199811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latinLnBrk="1">
              <a:lnSpc>
                <a:spcPct val="150000"/>
              </a:lnSpc>
              <a:spcAft>
                <a:spcPts val="0"/>
              </a:spcAft>
            </a:pPr>
            <a:r>
              <a:rPr lang="en-US" altLang="ko-KR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[1] </a:t>
            </a:r>
            <a:r>
              <a:rPr lang="en-US" altLang="ko-KR" sz="1200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ere</a:t>
            </a:r>
            <a:r>
              <a:rPr lang="en-US" altLang="ko-KR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, Heymans K, Kuiper M. </a:t>
            </a:r>
            <a:r>
              <a:rPr lang="en-US" altLang="ko-KR" sz="1200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iNGO</a:t>
            </a:r>
            <a:r>
              <a:rPr lang="en-US" altLang="ko-KR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a </a:t>
            </a:r>
            <a:r>
              <a:rPr lang="en-US" altLang="ko-KR" sz="1200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ytoscape</a:t>
            </a:r>
            <a:r>
              <a:rPr lang="en-US" altLang="ko-KR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lugin to assess overrepresentation of gene ontology categories in biological networks, Bioinformatics 2005;21:3448-3449.</a:t>
            </a:r>
            <a:endParaRPr lang="ko-KR" altLang="ko-KR" sz="1200" kern="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 latinLnBrk="1">
              <a:lnSpc>
                <a:spcPct val="150000"/>
              </a:lnSpc>
              <a:spcAft>
                <a:spcPts val="0"/>
              </a:spcAft>
            </a:pPr>
            <a:r>
              <a:rPr lang="en-US" altLang="ko-KR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[2] </a:t>
            </a:r>
            <a:r>
              <a:rPr lang="en-US" altLang="ko-KR" sz="1200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indea</a:t>
            </a:r>
            <a:r>
              <a:rPr lang="en-US" altLang="ko-KR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, </a:t>
            </a:r>
            <a:r>
              <a:rPr lang="en-US" altLang="ko-KR" sz="1200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lecnik</a:t>
            </a:r>
            <a:r>
              <a:rPr lang="en-US" altLang="ko-KR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, Hackl H et al. </a:t>
            </a:r>
            <a:r>
              <a:rPr lang="en-US" altLang="ko-KR" sz="1200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lueGO</a:t>
            </a:r>
            <a:r>
              <a:rPr lang="en-US" altLang="ko-KR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a </a:t>
            </a:r>
            <a:r>
              <a:rPr lang="en-US" altLang="ko-KR" sz="1200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ytoscape</a:t>
            </a:r>
            <a:r>
              <a:rPr lang="en-US" altLang="ko-KR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lug-in to decipher functionally grouped gene ontology and pathway annotation networks, Bioinformatics 2009;25:1091-1093.</a:t>
            </a:r>
            <a:endParaRPr lang="ko-KR" altLang="ko-KR" sz="1200" kern="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 latinLnBrk="1">
              <a:lnSpc>
                <a:spcPct val="150000"/>
              </a:lnSpc>
              <a:spcAft>
                <a:spcPts val="0"/>
              </a:spcAft>
            </a:pPr>
            <a:r>
              <a:rPr lang="en-US" altLang="ko-KR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[3] Merico D, </a:t>
            </a:r>
            <a:r>
              <a:rPr lang="en-US" altLang="ko-KR" sz="1200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sserlin</a:t>
            </a:r>
            <a:r>
              <a:rPr lang="en-US" altLang="ko-KR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, </a:t>
            </a:r>
            <a:r>
              <a:rPr lang="en-US" altLang="ko-KR" sz="1200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ueker</a:t>
            </a:r>
            <a:r>
              <a:rPr lang="en-US" altLang="ko-KR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 et al. Enrichment map: a network-based method for gene-set enrichment visualization and interpretation, </a:t>
            </a:r>
            <a:r>
              <a:rPr lang="en-US" altLang="ko-KR" sz="1200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LoS</a:t>
            </a:r>
            <a:r>
              <a:rPr lang="en-US" altLang="ko-KR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ne </a:t>
            </a:r>
            <a:r>
              <a:rPr lang="en-US" altLang="ko-KR" sz="1200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2010;5:e13984</a:t>
            </a:r>
            <a:r>
              <a:rPr lang="en-US" altLang="ko-KR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ko-KR" altLang="ko-KR" sz="1200" kern="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47598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테마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맑은 고딕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840</TotalTime>
  <Words>456</Words>
  <Application>Microsoft Office PowerPoint</Application>
  <PresentationFormat>A4 용지(210x297mm)</PresentationFormat>
  <Paragraphs>111</Paragraphs>
  <Slides>2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2</vt:i4>
      </vt:variant>
    </vt:vector>
  </HeadingPairs>
  <TitlesOfParts>
    <vt:vector size="8" baseType="lpstr">
      <vt:lpstr>Aptos</vt:lpstr>
      <vt:lpstr>Aptos Display</vt:lpstr>
      <vt:lpstr>맑은 고딕</vt:lpstr>
      <vt:lpstr>Arial</vt:lpstr>
      <vt:lpstr>Times New Roman</vt:lpstr>
      <vt:lpstr>Office 테마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윤석준</dc:creator>
  <cp:lastModifiedBy>eajeong</cp:lastModifiedBy>
  <cp:revision>379</cp:revision>
  <dcterms:created xsi:type="dcterms:W3CDTF">2024-12-19T07:01:18Z</dcterms:created>
  <dcterms:modified xsi:type="dcterms:W3CDTF">2025-12-01T09:01:05Z</dcterms:modified>
</cp:coreProperties>
</file>